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648" r:id="rId1"/>
  </p:sldMasterIdLst>
  <p:notesMasterIdLst>
    <p:notesMasterId r:id="rId22"/>
  </p:notesMasterIdLst>
  <p:sldIdLst>
    <p:sldId id="355" r:id="rId2"/>
    <p:sldId id="351" r:id="rId3"/>
    <p:sldId id="352" r:id="rId4"/>
    <p:sldId id="353" r:id="rId5"/>
    <p:sldId id="356" r:id="rId6"/>
    <p:sldId id="303" r:id="rId7"/>
    <p:sldId id="304" r:id="rId8"/>
    <p:sldId id="305" r:id="rId9"/>
    <p:sldId id="325" r:id="rId10"/>
    <p:sldId id="327" r:id="rId11"/>
    <p:sldId id="340" r:id="rId12"/>
    <p:sldId id="343" r:id="rId13"/>
    <p:sldId id="336" r:id="rId14"/>
    <p:sldId id="363" r:id="rId15"/>
    <p:sldId id="361" r:id="rId16"/>
    <p:sldId id="362" r:id="rId17"/>
    <p:sldId id="333" r:id="rId18"/>
    <p:sldId id="344" r:id="rId19"/>
    <p:sldId id="345" r:id="rId20"/>
    <p:sldId id="350" r:id="rId21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4" userDrawn="1">
          <p15:clr>
            <a:srgbClr val="A4A3A4"/>
          </p15:clr>
        </p15:guide>
        <p15:guide id="2" pos="2886" userDrawn="1">
          <p15:clr>
            <a:srgbClr val="A4A3A4"/>
          </p15:clr>
        </p15:guide>
        <p15:guide id="3" orient="horz" pos="2880">
          <p15:clr>
            <a:srgbClr val="A4A3A4"/>
          </p15:clr>
        </p15:guide>
        <p15:guide id="4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  <a:srgbClr val="FFFF99"/>
    <a:srgbClr val="00FF00"/>
    <a:srgbClr val="CC9900"/>
    <a:srgbClr val="FF6600"/>
    <a:srgbClr val="66FFFF"/>
    <a:srgbClr val="CC99FF"/>
    <a:srgbClr val="6699FF"/>
    <a:srgbClr val="CCECFF"/>
    <a:srgbClr val="CC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34" autoAdjust="0"/>
    <p:restoredTop sz="94674" autoAdjust="0"/>
  </p:normalViewPr>
  <p:slideViewPr>
    <p:cSldViewPr snapToGrid="0" snapToObjects="1">
      <p:cViewPr varScale="1">
        <p:scale>
          <a:sx n="59" d="100"/>
          <a:sy n="59" d="100"/>
        </p:scale>
        <p:origin x="2472" y="82"/>
      </p:cViewPr>
      <p:guideLst>
        <p:guide orient="horz" pos="2154"/>
        <p:guide pos="2886"/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C87E78-3C46-4BFD-A078-C4C637E113A1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592F7B-B4BA-45D1-BD8A-D8FAECC2271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5073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178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3129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7"/>
            <a:ext cx="1543050" cy="7802033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899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128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122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38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485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133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044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479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204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995CC0-FEB4-4E45-A550-ED451B346355}" type="datetimeFigureOut">
              <a:rPr lang="en-US" smtClean="0"/>
              <a:t>2/10/202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E0CAD2-6DB9-4018-A827-6D6C9BCC8F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649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">
            <a:extLst>
              <a:ext uri="{FF2B5EF4-FFF2-40B4-BE49-F238E27FC236}">
                <a16:creationId xmlns:a16="http://schemas.microsoft.com/office/drawing/2014/main" id="{02060648-2F40-1675-33DC-EC6D1B0369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9000" y="702000"/>
            <a:ext cx="5760000" cy="7584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</a:pPr>
            <a:r>
              <a:rPr lang="en-US" sz="1200" b="1" i="1" u="sng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s for:</a:t>
            </a:r>
            <a:endParaRPr lang="fr-FR" sz="1200" u="sng" dirty="0">
              <a:effectLst/>
              <a:latin typeface="Garamond" panose="02020404030301010803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</a:pP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sz="1200" dirty="0">
              <a:effectLst/>
              <a:latin typeface="Garamond" panose="02020404030301010803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</a:pPr>
            <a:r>
              <a:rPr lang="en-US" sz="1200" b="1" cap="all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ITLE: </a:t>
            </a:r>
            <a:r>
              <a:rPr lang="en-US" sz="1200" b="1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tional design of an artificial tethered enzyme for non-templated post-transcriptional mRNA polyadenylation by the second generation of the C3P3 system</a:t>
            </a:r>
            <a:endParaRPr lang="fr-FR" sz="1200" dirty="0">
              <a:effectLst/>
              <a:latin typeface="Garamond" panose="02020404030301010803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</a:pP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UNNING TITLE</a:t>
            </a:r>
            <a:r>
              <a:rPr lang="en-US" sz="120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Non-templated </a:t>
            </a: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lyadenylation enzyme for the second generation of the C3P3 system</a:t>
            </a:r>
            <a:endParaRPr lang="fr-FR" sz="1200" dirty="0">
              <a:effectLst/>
              <a:latin typeface="Garamond" panose="02020404030301010803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Bef>
                <a:spcPts val="1800"/>
              </a:spcBef>
              <a:spcAft>
                <a:spcPts val="300"/>
              </a:spcAft>
            </a:pPr>
            <a:r>
              <a:rPr lang="en-US" sz="1200" cap="small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assification: biological sciences, System Biology</a:t>
            </a:r>
            <a:endParaRPr lang="fr-FR" sz="1200" dirty="0">
              <a:effectLst/>
              <a:latin typeface="Garamond" panose="02020404030301010803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</a:pP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eywords: C3P3, mRNA, polyadenylation, poly(A) polymerase, artificial expression system</a:t>
            </a:r>
            <a:endParaRPr lang="fr-FR" sz="1200" dirty="0">
              <a:effectLst/>
              <a:latin typeface="Garamond" panose="02020404030301010803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Bef>
                <a:spcPts val="1800"/>
              </a:spcBef>
              <a:spcAft>
                <a:spcPts val="300"/>
              </a:spcAft>
            </a:pPr>
            <a:r>
              <a:rPr lang="en-US" sz="1200" cap="small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uthors: </a:t>
            </a: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rine Le </a:t>
            </a:r>
            <a:r>
              <a:rPr lang="en-US" sz="1200" dirty="0" err="1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ulch</a:t>
            </a: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.S.</a:t>
            </a:r>
            <a:r>
              <a:rPr lang="en-US" sz="1200" baseline="300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ric </a:t>
            </a:r>
            <a:r>
              <a:rPr lang="en-US" sz="1200" dirty="0" err="1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acquet</a:t>
            </a: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h.D.</a:t>
            </a:r>
            <a:r>
              <a:rPr lang="en-US" sz="1200" baseline="300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aïma</a:t>
            </a: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hiri</a:t>
            </a: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h.D.</a:t>
            </a:r>
            <a:r>
              <a:rPr lang="en-US" sz="1200" baseline="300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ya Shmulevitz, Ph.D.</a:t>
            </a:r>
            <a:r>
              <a:rPr lang="en-US" sz="1200" baseline="300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hilippe H. Jaïs, M.D. Ph.D.</a:t>
            </a:r>
            <a:r>
              <a:rPr lang="en-US" sz="1200" baseline="300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*</a:t>
            </a:r>
            <a:endParaRPr lang="fr-FR" sz="1200" dirty="0">
              <a:effectLst/>
              <a:latin typeface="Garamond" panose="02020404030301010803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90170" indent="-90170" algn="just">
              <a:lnSpc>
                <a:spcPct val="130000"/>
              </a:lnSpc>
              <a:spcBef>
                <a:spcPts val="1800"/>
              </a:spcBef>
              <a:spcAft>
                <a:spcPts val="300"/>
              </a:spcAft>
            </a:pPr>
            <a:r>
              <a:rPr lang="fr-FR" sz="1200" baseline="30000" dirty="0">
                <a:effectLst/>
                <a:latin typeface="Garamond" panose="02020404030301010803" pitchFamily="18" charset="0"/>
                <a:ea typeface="PMingLiU" panose="02020500000000000000" pitchFamily="18" charset="-120"/>
              </a:rPr>
              <a:t>1 	</a:t>
            </a:r>
            <a:r>
              <a:rPr lang="fr-FR" sz="1200" dirty="0">
                <a:effectLst/>
                <a:latin typeface="Garamond" panose="02020404030301010803" pitchFamily="18" charset="0"/>
                <a:ea typeface="PMingLiU" panose="02020500000000000000" pitchFamily="18" charset="-120"/>
              </a:rPr>
              <a:t>Eukarÿs SAS, Pépinière Genopole, 4 rue Pierre Fontaine, 91000 Evry-Courcouronnes, France,</a:t>
            </a:r>
          </a:p>
          <a:p>
            <a:pPr marL="90170" indent="-90170" algn="just">
              <a:lnSpc>
                <a:spcPct val="130000"/>
              </a:lnSpc>
              <a:spcBef>
                <a:spcPts val="300"/>
              </a:spcBef>
              <a:spcAft>
                <a:spcPts val="300"/>
              </a:spcAft>
            </a:pPr>
            <a:r>
              <a:rPr lang="fr-FR" sz="1200" baseline="30000" dirty="0">
                <a:effectLst/>
                <a:latin typeface="Garamond" panose="02020404030301010803" pitchFamily="18" charset="0"/>
                <a:ea typeface="PMingLiU" panose="02020500000000000000" pitchFamily="18" charset="-120"/>
              </a:rPr>
              <a:t>2</a:t>
            </a:r>
            <a:r>
              <a:rPr lang="fr-FR" sz="1200" dirty="0">
                <a:effectLst/>
                <a:latin typeface="Garamond" panose="02020404030301010803" pitchFamily="18" charset="0"/>
                <a:ea typeface="PMingLiU" panose="02020500000000000000" pitchFamily="18" charset="-120"/>
              </a:rPr>
              <a:t>	Institut de Chimie des Substances Naturelles, CNRS UPR2301, Université Paris-Saclay, Avenue de la Terrasse, 91198 Gif-sur-Yvette, France,</a:t>
            </a:r>
          </a:p>
          <a:p>
            <a:pPr marL="90170" indent="-90170" algn="just">
              <a:lnSpc>
                <a:spcPct val="130000"/>
              </a:lnSpc>
              <a:spcBef>
                <a:spcPts val="300"/>
              </a:spcBef>
              <a:spcAft>
                <a:spcPts val="300"/>
              </a:spcAft>
            </a:pPr>
            <a:r>
              <a:rPr lang="en-US" sz="1200" baseline="30000" dirty="0">
                <a:effectLst/>
                <a:latin typeface="Garamond" panose="02020404030301010803" pitchFamily="18" charset="0"/>
                <a:ea typeface="PMingLiU" panose="02020500000000000000" pitchFamily="18" charset="-120"/>
              </a:rPr>
              <a:t>3</a:t>
            </a:r>
            <a:r>
              <a:rPr lang="en-US" sz="1200" dirty="0">
                <a:effectLst/>
                <a:latin typeface="Garamond" panose="02020404030301010803" pitchFamily="18" charset="0"/>
                <a:ea typeface="PMingLiU" panose="02020500000000000000" pitchFamily="18" charset="-120"/>
              </a:rPr>
              <a:t>	Medical Microbiology and Immunology, Li Ka Shing Institute of Virology, University of Alberta, 6-142J Katz Group Centre for Pharmacy &amp; Health Research, 114 Street NW, Edmonton, Alberta, T6G 2E1, Canada.</a:t>
            </a:r>
            <a:endParaRPr lang="fr-FR" sz="1200" dirty="0">
              <a:effectLst/>
              <a:latin typeface="Garamond" panose="02020404030301010803" pitchFamily="18" charset="0"/>
              <a:ea typeface="PMingLiU" panose="02020500000000000000" pitchFamily="18" charset="-120"/>
            </a:endParaRPr>
          </a:p>
          <a:p>
            <a:pPr marL="90170" indent="-90170" algn="just">
              <a:lnSpc>
                <a:spcPct val="130000"/>
              </a:lnSpc>
              <a:spcBef>
                <a:spcPts val="300"/>
              </a:spcBef>
              <a:spcAft>
                <a:spcPts val="300"/>
              </a:spcAft>
            </a:pPr>
            <a:r>
              <a:rPr lang="en-US" sz="1200" dirty="0">
                <a:effectLst/>
                <a:latin typeface="Garamond" panose="02020404030301010803" pitchFamily="18" charset="0"/>
                <a:ea typeface="PMingLiU" panose="02020500000000000000" pitchFamily="18" charset="-120"/>
              </a:rPr>
              <a:t> </a:t>
            </a:r>
            <a:endParaRPr lang="fr-FR" sz="1200" dirty="0">
              <a:effectLst/>
              <a:latin typeface="Garamond" panose="02020404030301010803" pitchFamily="18" charset="0"/>
              <a:ea typeface="PMingLiU" panose="02020500000000000000" pitchFamily="18" charset="-120"/>
            </a:endParaRPr>
          </a:p>
          <a:p>
            <a:pPr marL="90170" indent="-90170" algn="just">
              <a:lnSpc>
                <a:spcPct val="130000"/>
              </a:lnSpc>
              <a:spcBef>
                <a:spcPts val="300"/>
              </a:spcBef>
              <a:spcAft>
                <a:spcPts val="300"/>
              </a:spcAft>
              <a:tabLst>
                <a:tab pos="3524885" algn="l"/>
              </a:tabLst>
            </a:pPr>
            <a:r>
              <a:rPr lang="en-US" sz="1200" baseline="30000" dirty="0">
                <a:effectLst/>
                <a:latin typeface="Garamond" panose="02020404030301010803" pitchFamily="18" charset="0"/>
                <a:ea typeface="PMingLiU" panose="02020500000000000000" pitchFamily="18" charset="-120"/>
              </a:rPr>
              <a:t>*</a:t>
            </a:r>
            <a:r>
              <a:rPr lang="en-US" sz="1200" dirty="0">
                <a:effectLst/>
                <a:latin typeface="Garamond" panose="02020404030301010803" pitchFamily="18" charset="0"/>
                <a:ea typeface="PMingLiU" panose="02020500000000000000" pitchFamily="18" charset="-120"/>
              </a:rPr>
              <a:t>	To whom correspondence should be addressed.	</a:t>
            </a:r>
            <a:endParaRPr lang="fr-FR" sz="1200" dirty="0">
              <a:effectLst/>
              <a:latin typeface="Garamond" panose="02020404030301010803" pitchFamily="18" charset="0"/>
              <a:ea typeface="PMingLiU" panose="02020500000000000000" pitchFamily="18" charset="-120"/>
            </a:endParaRPr>
          </a:p>
          <a:p>
            <a:pPr algn="just">
              <a:lnSpc>
                <a:spcPct val="115000"/>
              </a:lnSpc>
              <a:spcBef>
                <a:spcPts val="1800"/>
              </a:spcBef>
              <a:spcAft>
                <a:spcPts val="300"/>
              </a:spcAft>
            </a:pPr>
            <a:r>
              <a:rPr lang="en-US" sz="1200" u="sng" cap="small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ress for correspondence</a:t>
            </a:r>
            <a:endParaRPr lang="fr-FR" sz="1200" dirty="0">
              <a:effectLst/>
              <a:latin typeface="Garamond" panose="02020404030301010803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ilippe H. Jaïs</a:t>
            </a:r>
            <a:endParaRPr lang="fr-FR" sz="1200" dirty="0">
              <a:effectLst/>
              <a:latin typeface="Garamond" panose="02020404030301010803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fr-FR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karÿs SAS</a:t>
            </a:r>
          </a:p>
          <a:p>
            <a:pPr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fr-FR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opole Entreprises Campus 3</a:t>
            </a:r>
          </a:p>
          <a:p>
            <a:pPr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fr-FR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 rue Pierre Fontaine</a:t>
            </a:r>
          </a:p>
          <a:p>
            <a:pPr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fr-FR" sz="1200" dirty="0"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91000 Evry-Courcouronnes, France</a:t>
            </a:r>
            <a:endParaRPr lang="fr-FR" sz="1100" dirty="0">
              <a:effectLst/>
              <a:latin typeface="Garamond" panose="02020404030301010803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394041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>
            <a:extLst>
              <a:ext uri="{FF2B5EF4-FFF2-40B4-BE49-F238E27FC236}">
                <a16:creationId xmlns:a16="http://schemas.microsoft.com/office/drawing/2014/main" id="{90B87FBD-C0B3-898F-4E37-32AABFE8F5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6143" y="4124591"/>
            <a:ext cx="5040000" cy="2818065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2922343E-5231-2DA1-8B97-2122909DADFB}"/>
              </a:ext>
            </a:extLst>
          </p:cNvPr>
          <p:cNvSpPr txBox="1"/>
          <p:nvPr/>
        </p:nvSpPr>
        <p:spPr>
          <a:xfrm>
            <a:off x="2005117" y="8738466"/>
            <a:ext cx="2847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</a:t>
            </a:r>
            <a:r>
              <a:rPr lang="fr-FR" b="1" dirty="0"/>
              <a:t>Figure 5 A-B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B30B7BBA-1171-66D2-3123-D0F563AF5B49}"/>
              </a:ext>
            </a:extLst>
          </p:cNvPr>
          <p:cNvSpPr txBox="1"/>
          <p:nvPr/>
        </p:nvSpPr>
        <p:spPr>
          <a:xfrm>
            <a:off x="180975" y="412459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C10FFEAC-5501-98CC-D28D-1BA9EE4859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9000" y="326005"/>
            <a:ext cx="5400000" cy="2745652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C25A50A3-7362-79A9-1C64-CFFB07E54714}"/>
              </a:ext>
            </a:extLst>
          </p:cNvPr>
          <p:cNvSpPr txBox="1"/>
          <p:nvPr/>
        </p:nvSpPr>
        <p:spPr>
          <a:xfrm>
            <a:off x="180975" y="32600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404489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F59A3B9C-5BB2-8E67-D93A-E8784B1E85EF}"/>
              </a:ext>
            </a:extLst>
          </p:cNvPr>
          <p:cNvGrpSpPr>
            <a:grpSpLocks noChangeAspect="1"/>
          </p:cNvGrpSpPr>
          <p:nvPr/>
        </p:nvGrpSpPr>
        <p:grpSpPr>
          <a:xfrm>
            <a:off x="854194" y="682205"/>
            <a:ext cx="5482190" cy="3204000"/>
            <a:chOff x="1647823" y="6198417"/>
            <a:chExt cx="4143378" cy="2421552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96F446DB-0094-49EA-6D9E-D2C7EE9BF8F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47823" y="6198417"/>
              <a:ext cx="4143378" cy="2421552"/>
            </a:xfrm>
            <a:prstGeom prst="rect">
              <a:avLst/>
            </a:prstGeom>
          </p:spPr>
        </p:pic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C8D1C061-B2B9-3E21-AB8D-C5C3C4A16FE9}"/>
                </a:ext>
              </a:extLst>
            </p:cNvPr>
            <p:cNvSpPr txBox="1"/>
            <p:nvPr/>
          </p:nvSpPr>
          <p:spPr>
            <a:xfrm>
              <a:off x="2276475" y="6402943"/>
              <a:ext cx="822873" cy="3023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>
                  <a:solidFill>
                    <a:srgbClr val="00B050"/>
                  </a:solidFill>
                </a:rPr>
                <a:t>C3P3-G1</a:t>
              </a:r>
            </a:p>
          </p:txBody>
        </p:sp>
        <p:cxnSp>
          <p:nvCxnSpPr>
            <p:cNvPr id="5" name="Connecteur droit avec flèche 4">
              <a:extLst>
                <a:ext uri="{FF2B5EF4-FFF2-40B4-BE49-F238E27FC236}">
                  <a16:creationId xmlns:a16="http://schemas.microsoft.com/office/drawing/2014/main" id="{CE322E7A-13A8-4FFB-7143-7EA6AAE25438}"/>
                </a:ext>
              </a:extLst>
            </p:cNvPr>
            <p:cNvCxnSpPr>
              <a:cxnSpLocks/>
              <a:stCxn id="4" idx="2"/>
            </p:cNvCxnSpPr>
            <p:nvPr/>
          </p:nvCxnSpPr>
          <p:spPr>
            <a:xfrm flipH="1">
              <a:off x="2684600" y="6705342"/>
              <a:ext cx="3312" cy="293379"/>
            </a:xfrm>
            <a:prstGeom prst="straightConnector1">
              <a:avLst/>
            </a:prstGeom>
            <a:ln w="1905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34257902-7EC2-DED9-8D67-2CBF96F5FC37}"/>
                </a:ext>
              </a:extLst>
            </p:cNvPr>
            <p:cNvSpPr txBox="1"/>
            <p:nvPr/>
          </p:nvSpPr>
          <p:spPr>
            <a:xfrm>
              <a:off x="3511605" y="6402943"/>
              <a:ext cx="1969175" cy="3023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>
                  <a:solidFill>
                    <a:srgbClr val="FF0000"/>
                  </a:solidFill>
                </a:rPr>
                <a:t>N</a:t>
              </a:r>
              <a:r>
                <a:rPr lang="el-GR" sz="2000" b="1" dirty="0">
                  <a:solidFill>
                    <a:srgbClr val="FF0000"/>
                  </a:solidFill>
                </a:rPr>
                <a:t>λ-</a:t>
              </a:r>
              <a:r>
                <a:rPr lang="fr-FR" sz="2000" b="1" dirty="0">
                  <a:solidFill>
                    <a:srgbClr val="FF0000"/>
                  </a:solidFill>
                </a:rPr>
                <a:t>PAP</a:t>
              </a:r>
              <a:r>
                <a:rPr lang="el-GR" sz="2000" b="1" dirty="0">
                  <a:solidFill>
                    <a:srgbClr val="FF0000"/>
                  </a:solidFill>
                </a:rPr>
                <a:t>α</a:t>
              </a:r>
              <a:r>
                <a:rPr lang="fr-FR" sz="2000" b="1" dirty="0">
                  <a:solidFill>
                    <a:srgbClr val="FF0000"/>
                  </a:solidFill>
                </a:rPr>
                <a:t>m7 + C3P3-G1</a:t>
              </a:r>
            </a:p>
          </p:txBody>
        </p:sp>
        <p:cxnSp>
          <p:nvCxnSpPr>
            <p:cNvPr id="7" name="Connecteur droit avec flèche 6">
              <a:extLst>
                <a:ext uri="{FF2B5EF4-FFF2-40B4-BE49-F238E27FC236}">
                  <a16:creationId xmlns:a16="http://schemas.microsoft.com/office/drawing/2014/main" id="{3B726858-FE08-718E-4C73-8000919F3007}"/>
                </a:ext>
              </a:extLst>
            </p:cNvPr>
            <p:cNvCxnSpPr>
              <a:cxnSpLocks/>
              <a:stCxn id="6" idx="2"/>
            </p:cNvCxnSpPr>
            <p:nvPr/>
          </p:nvCxnSpPr>
          <p:spPr>
            <a:xfrm>
              <a:off x="4496193" y="6705342"/>
              <a:ext cx="1" cy="293379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ZoneTexte 9">
            <a:extLst>
              <a:ext uri="{FF2B5EF4-FFF2-40B4-BE49-F238E27FC236}">
                <a16:creationId xmlns:a16="http://schemas.microsoft.com/office/drawing/2014/main" id="{B6463581-BA54-8ADC-CA30-8480CE5FA2CF}"/>
              </a:ext>
            </a:extLst>
          </p:cNvPr>
          <p:cNvSpPr txBox="1"/>
          <p:nvPr/>
        </p:nvSpPr>
        <p:spPr>
          <a:xfrm>
            <a:off x="2005117" y="8738466"/>
            <a:ext cx="2847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</a:t>
            </a:r>
            <a:r>
              <a:rPr lang="fr-FR" b="1" dirty="0"/>
              <a:t>Figure 6 A-B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0F6C6B5E-A88F-B9E2-4114-BB5D84D166AB}"/>
              </a:ext>
            </a:extLst>
          </p:cNvPr>
          <p:cNvSpPr txBox="1"/>
          <p:nvPr/>
        </p:nvSpPr>
        <p:spPr>
          <a:xfrm>
            <a:off x="109537" y="57868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AAD0DD90-7E78-E204-E415-78D3E67D69F4}"/>
              </a:ext>
            </a:extLst>
          </p:cNvPr>
          <p:cNvSpPr txBox="1"/>
          <p:nvPr/>
        </p:nvSpPr>
        <p:spPr>
          <a:xfrm>
            <a:off x="109537" y="450506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C1E546A2-39FC-DEB1-0ED3-5F1AD33160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9550" y="4505061"/>
            <a:ext cx="5400000" cy="34524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566189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>
            <a:extLst>
              <a:ext uri="{FF2B5EF4-FFF2-40B4-BE49-F238E27FC236}">
                <a16:creationId xmlns:a16="http://schemas.microsoft.com/office/drawing/2014/main" id="{B6463581-BA54-8ADC-CA30-8480CE5FA2CF}"/>
              </a:ext>
            </a:extLst>
          </p:cNvPr>
          <p:cNvSpPr txBox="1"/>
          <p:nvPr/>
        </p:nvSpPr>
        <p:spPr>
          <a:xfrm>
            <a:off x="2114121" y="8738466"/>
            <a:ext cx="2629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/>
              <a:t>Supplementary </a:t>
            </a:r>
            <a:r>
              <a:rPr lang="fr-FR" b="1" dirty="0"/>
              <a:t>Figure 6 C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0F6C6B5E-A88F-B9E2-4114-BB5D84D166AB}"/>
              </a:ext>
            </a:extLst>
          </p:cNvPr>
          <p:cNvSpPr txBox="1"/>
          <p:nvPr/>
        </p:nvSpPr>
        <p:spPr>
          <a:xfrm>
            <a:off x="109537" y="104512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75054096-6948-827E-A55B-0484558D4D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956" y="1045122"/>
            <a:ext cx="5400000" cy="31468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74558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6DC9632E-FAC3-2D17-88D8-7C3D03BA6C6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008"/>
          <a:stretch/>
        </p:blipFill>
        <p:spPr>
          <a:xfrm>
            <a:off x="729000" y="863264"/>
            <a:ext cx="5400000" cy="3143040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8FA7C7EA-F323-6697-4A9A-54B2885CDE49}"/>
              </a:ext>
            </a:extLst>
          </p:cNvPr>
          <p:cNvSpPr txBox="1"/>
          <p:nvPr/>
        </p:nvSpPr>
        <p:spPr>
          <a:xfrm>
            <a:off x="2005117" y="8774668"/>
            <a:ext cx="2847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7</a:t>
            </a:r>
            <a:r>
              <a:rPr lang="fr-FR" b="1" dirty="0"/>
              <a:t> A-B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1B81F3CC-339B-CB2E-01C6-EC7EE61A42DA}"/>
              </a:ext>
            </a:extLst>
          </p:cNvPr>
          <p:cNvSpPr txBox="1"/>
          <p:nvPr/>
        </p:nvSpPr>
        <p:spPr>
          <a:xfrm>
            <a:off x="180301" y="86326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86FF22B5-12D7-7C67-DCFB-DBEE433FD9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9000" y="4750443"/>
            <a:ext cx="5400000" cy="3027493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18451885-077D-CB88-947F-52C393BA1839}"/>
              </a:ext>
            </a:extLst>
          </p:cNvPr>
          <p:cNvSpPr txBox="1"/>
          <p:nvPr/>
        </p:nvSpPr>
        <p:spPr>
          <a:xfrm>
            <a:off x="293367" y="4750442"/>
            <a:ext cx="349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79720746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8FA7C7EA-F323-6697-4A9A-54B2885CDE49}"/>
              </a:ext>
            </a:extLst>
          </p:cNvPr>
          <p:cNvSpPr txBox="1"/>
          <p:nvPr/>
        </p:nvSpPr>
        <p:spPr>
          <a:xfrm>
            <a:off x="2005117" y="8774668"/>
            <a:ext cx="2629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7</a:t>
            </a:r>
            <a:r>
              <a:rPr lang="fr-FR" b="1" dirty="0"/>
              <a:t> C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0F063132-CBD2-0874-FE61-5762B676A6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000" y="2939739"/>
            <a:ext cx="5400000" cy="3060490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1B81F3CC-339B-CB2E-01C6-EC7EE61A42DA}"/>
              </a:ext>
            </a:extLst>
          </p:cNvPr>
          <p:cNvSpPr txBox="1"/>
          <p:nvPr/>
        </p:nvSpPr>
        <p:spPr>
          <a:xfrm>
            <a:off x="206427" y="86326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6752067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>
            <a:extLst>
              <a:ext uri="{FF2B5EF4-FFF2-40B4-BE49-F238E27FC236}">
                <a16:creationId xmlns:a16="http://schemas.microsoft.com/office/drawing/2014/main" id="{CF14630D-A8D2-DC74-4F0A-60F9A92469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8324" y="4452251"/>
            <a:ext cx="4590000" cy="3025227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559ED702-607C-1C43-EC5A-C3B60D6789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0593" y="115403"/>
            <a:ext cx="4651200" cy="3035382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1B133C3B-B10C-C668-57A5-754C51CD635E}"/>
              </a:ext>
            </a:extLst>
          </p:cNvPr>
          <p:cNvSpPr txBox="1"/>
          <p:nvPr/>
        </p:nvSpPr>
        <p:spPr>
          <a:xfrm>
            <a:off x="2005117" y="8774668"/>
            <a:ext cx="2847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/>
              <a:t>Supplementary </a:t>
            </a:r>
            <a:r>
              <a:rPr lang="fr-FR" b="1" dirty="0"/>
              <a:t>Figure 8 A-B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B04154D7-A487-DD6A-EA0E-A8C451CF5B77}"/>
              </a:ext>
            </a:extLst>
          </p:cNvPr>
          <p:cNvSpPr txBox="1"/>
          <p:nvPr/>
        </p:nvSpPr>
        <p:spPr>
          <a:xfrm>
            <a:off x="323850" y="2088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91DC5D65-9E31-B48B-6930-9002927FFCC7}"/>
              </a:ext>
            </a:extLst>
          </p:cNvPr>
          <p:cNvSpPr txBox="1"/>
          <p:nvPr/>
        </p:nvSpPr>
        <p:spPr>
          <a:xfrm>
            <a:off x="305123" y="447782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4220BE9-972C-8924-4AF1-999F251107B3}"/>
              </a:ext>
            </a:extLst>
          </p:cNvPr>
          <p:cNvSpPr/>
          <p:nvPr/>
        </p:nvSpPr>
        <p:spPr>
          <a:xfrm>
            <a:off x="1496725" y="3571660"/>
            <a:ext cx="211756" cy="2007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9" name="Tableau 8">
            <a:extLst>
              <a:ext uri="{FF2B5EF4-FFF2-40B4-BE49-F238E27FC236}">
                <a16:creationId xmlns:a16="http://schemas.microsoft.com/office/drawing/2014/main" id="{EDAA3EE9-D881-3054-1C6E-DB292D0C7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7193777"/>
              </p:ext>
            </p:extLst>
          </p:nvPr>
        </p:nvGraphicFramePr>
        <p:xfrm>
          <a:off x="749870" y="3038300"/>
          <a:ext cx="4990521" cy="1310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34466">
                  <a:extLst>
                    <a:ext uri="{9D8B030D-6E8A-4147-A177-3AD203B41FA5}">
                      <a16:colId xmlns:a16="http://schemas.microsoft.com/office/drawing/2014/main" val="2196802958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67857554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50863009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728650218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05614660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2880264063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08437749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146814882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279455906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25697952"/>
                    </a:ext>
                  </a:extLst>
                </a:gridCol>
              </a:tblGrid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SO 10%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0736466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1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7930308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1 enzymatically-dead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103015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2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2817089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2 enzymatically-dead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74609478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Luciferase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0313278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MVScript-Luciferase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14453998"/>
                  </a:ext>
                </a:extLst>
              </a:tr>
              <a:tr h="1251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 (ANOVA)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***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***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19768972"/>
                  </a:ext>
                </a:extLst>
              </a:tr>
            </a:tbl>
          </a:graphicData>
        </a:graphic>
      </p:graphicFrame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4DB2B5CB-9C6D-DFFB-5D1C-D8751043F05B}"/>
              </a:ext>
            </a:extLst>
          </p:cNvPr>
          <p:cNvCxnSpPr/>
          <p:nvPr/>
        </p:nvCxnSpPr>
        <p:spPr>
          <a:xfrm>
            <a:off x="2320394" y="2161527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id="{E2DE67FD-56BD-498D-1091-3112C41BBCFF}"/>
              </a:ext>
            </a:extLst>
          </p:cNvPr>
          <p:cNvCxnSpPr/>
          <p:nvPr/>
        </p:nvCxnSpPr>
        <p:spPr>
          <a:xfrm>
            <a:off x="2357999" y="6441476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1" name="Tableau 10">
            <a:extLst>
              <a:ext uri="{FF2B5EF4-FFF2-40B4-BE49-F238E27FC236}">
                <a16:creationId xmlns:a16="http://schemas.microsoft.com/office/drawing/2014/main" id="{9F36FFBE-5DD1-C328-A591-E03DEFDC71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2659086"/>
              </p:ext>
            </p:extLst>
          </p:nvPr>
        </p:nvGraphicFramePr>
        <p:xfrm>
          <a:off x="761968" y="7389923"/>
          <a:ext cx="4990521" cy="1310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34466">
                  <a:extLst>
                    <a:ext uri="{9D8B030D-6E8A-4147-A177-3AD203B41FA5}">
                      <a16:colId xmlns:a16="http://schemas.microsoft.com/office/drawing/2014/main" val="2196802958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67857554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50863009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728650218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05614660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2880264063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08437749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146814882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279455906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25697952"/>
                    </a:ext>
                  </a:extLst>
                </a:gridCol>
              </a:tblGrid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SO 10%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0736466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1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7930308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1 enzymatically-dead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103015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2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2817089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2 enzymatically-dead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74609478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Luciferase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0313278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MVScript-Luciferase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14453998"/>
                  </a:ext>
                </a:extLst>
              </a:tr>
              <a:tr h="1251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 (ANOVA)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***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***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197689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841254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 9">
            <a:extLst>
              <a:ext uri="{FF2B5EF4-FFF2-40B4-BE49-F238E27FC236}">
                <a16:creationId xmlns:a16="http://schemas.microsoft.com/office/drawing/2014/main" id="{048C3044-B6F3-8DED-F04C-3F46D436FF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9141" y="4445720"/>
            <a:ext cx="4590000" cy="3025227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A8A106B2-57C6-3280-BD23-DAC11ABF24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4734" y="120599"/>
            <a:ext cx="4734000" cy="3025587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1B133C3B-B10C-C668-57A5-754C51CD635E}"/>
              </a:ext>
            </a:extLst>
          </p:cNvPr>
          <p:cNvSpPr txBox="1"/>
          <p:nvPr/>
        </p:nvSpPr>
        <p:spPr>
          <a:xfrm>
            <a:off x="2005918" y="8774668"/>
            <a:ext cx="2846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/>
              <a:t>Supplementary </a:t>
            </a:r>
            <a:r>
              <a:rPr lang="fr-FR" b="1" dirty="0"/>
              <a:t>Figure 8 C-D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B04154D7-A487-DD6A-EA0E-A8C451CF5B77}"/>
              </a:ext>
            </a:extLst>
          </p:cNvPr>
          <p:cNvSpPr txBox="1"/>
          <p:nvPr/>
        </p:nvSpPr>
        <p:spPr>
          <a:xfrm>
            <a:off x="323850" y="2088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91DC5D65-9E31-B48B-6930-9002927FFCC7}"/>
              </a:ext>
            </a:extLst>
          </p:cNvPr>
          <p:cNvSpPr txBox="1"/>
          <p:nvPr/>
        </p:nvSpPr>
        <p:spPr>
          <a:xfrm>
            <a:off x="305123" y="447782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4220BE9-972C-8924-4AF1-999F251107B3}"/>
              </a:ext>
            </a:extLst>
          </p:cNvPr>
          <p:cNvSpPr/>
          <p:nvPr/>
        </p:nvSpPr>
        <p:spPr>
          <a:xfrm>
            <a:off x="1457542" y="3571660"/>
            <a:ext cx="211756" cy="2007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9" name="Tableau 8">
            <a:extLst>
              <a:ext uri="{FF2B5EF4-FFF2-40B4-BE49-F238E27FC236}">
                <a16:creationId xmlns:a16="http://schemas.microsoft.com/office/drawing/2014/main" id="{EDAA3EE9-D881-3054-1C6E-DB292D0C7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5744378"/>
              </p:ext>
            </p:extLst>
          </p:nvPr>
        </p:nvGraphicFramePr>
        <p:xfrm>
          <a:off x="642955" y="3052814"/>
          <a:ext cx="4990521" cy="1310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34466">
                  <a:extLst>
                    <a:ext uri="{9D8B030D-6E8A-4147-A177-3AD203B41FA5}">
                      <a16:colId xmlns:a16="http://schemas.microsoft.com/office/drawing/2014/main" val="2196802958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67857554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50863009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728650218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05614660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2880264063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08437749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146814882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279455906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25697952"/>
                    </a:ext>
                  </a:extLst>
                </a:gridCol>
              </a:tblGrid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SO 10%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0736466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1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7930308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1 enzymatically-dead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103015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2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2817089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2 enzymatically-dead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74609478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Luciferase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0313278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MVScript-Luciferase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14453998"/>
                  </a:ext>
                </a:extLst>
              </a:tr>
              <a:tr h="1251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 (ANOVA)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***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***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19768972"/>
                  </a:ext>
                </a:extLst>
              </a:tr>
            </a:tbl>
          </a:graphicData>
        </a:graphic>
      </p:graphicFrame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4DB2B5CB-9C6D-DFFB-5D1C-D8751043F05B}"/>
              </a:ext>
            </a:extLst>
          </p:cNvPr>
          <p:cNvCxnSpPr/>
          <p:nvPr/>
        </p:nvCxnSpPr>
        <p:spPr>
          <a:xfrm>
            <a:off x="2242507" y="1956068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id="{E2DE67FD-56BD-498D-1091-3112C41BBCFF}"/>
              </a:ext>
            </a:extLst>
          </p:cNvPr>
          <p:cNvCxnSpPr/>
          <p:nvPr/>
        </p:nvCxnSpPr>
        <p:spPr>
          <a:xfrm>
            <a:off x="2309852" y="6387930"/>
            <a:ext cx="3420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1" name="Tableau 10">
            <a:extLst>
              <a:ext uri="{FF2B5EF4-FFF2-40B4-BE49-F238E27FC236}">
                <a16:creationId xmlns:a16="http://schemas.microsoft.com/office/drawing/2014/main" id="{9F36FFBE-5DD1-C328-A591-E03DEFDC71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3877547"/>
              </p:ext>
            </p:extLst>
          </p:nvPr>
        </p:nvGraphicFramePr>
        <p:xfrm>
          <a:off x="722785" y="7396454"/>
          <a:ext cx="4990521" cy="1310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34466">
                  <a:extLst>
                    <a:ext uri="{9D8B030D-6E8A-4147-A177-3AD203B41FA5}">
                      <a16:colId xmlns:a16="http://schemas.microsoft.com/office/drawing/2014/main" val="2196802958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67857554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50863009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728650218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05614660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2880264063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08437749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3146814882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2794559067"/>
                    </a:ext>
                  </a:extLst>
                </a:gridCol>
                <a:gridCol w="372895">
                  <a:extLst>
                    <a:ext uri="{9D8B030D-6E8A-4147-A177-3AD203B41FA5}">
                      <a16:colId xmlns:a16="http://schemas.microsoft.com/office/drawing/2014/main" val="1625697952"/>
                    </a:ext>
                  </a:extLst>
                </a:gridCol>
              </a:tblGrid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SO 10%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b="1" kern="1200" noProof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0736466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1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7930308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1 enzymatically-dead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103015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2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2817089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G2 enzymatically-dead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74609478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P3-Luciferase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03132781"/>
                  </a:ext>
                </a:extLst>
              </a:tr>
              <a:tr h="15012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MVScript-Luciferase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14453998"/>
                  </a:ext>
                </a:extLst>
              </a:tr>
              <a:tr h="1251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 (ANOVA)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***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***</a:t>
                      </a: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197689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6815961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 8">
            <a:extLst>
              <a:ext uri="{FF2B5EF4-FFF2-40B4-BE49-F238E27FC236}">
                <a16:creationId xmlns:a16="http://schemas.microsoft.com/office/drawing/2014/main" id="{EB0442D8-ADFB-C13B-312C-1B4837246A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1546" y="4638714"/>
            <a:ext cx="5040000" cy="3564560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4C195320-F9B1-2797-4F1E-A81BEDE841E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524"/>
          <a:stretch/>
        </p:blipFill>
        <p:spPr>
          <a:xfrm>
            <a:off x="728999" y="443956"/>
            <a:ext cx="5858175" cy="3529291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6BA2A2CF-3309-5FF6-BB70-5001C0763505}"/>
              </a:ext>
            </a:extLst>
          </p:cNvPr>
          <p:cNvSpPr txBox="1"/>
          <p:nvPr/>
        </p:nvSpPr>
        <p:spPr>
          <a:xfrm>
            <a:off x="2005117" y="8774668"/>
            <a:ext cx="2847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/>
              <a:t>Supplementary </a:t>
            </a:r>
            <a:r>
              <a:rPr lang="fr-FR" b="1" dirty="0"/>
              <a:t>Figure 9 A-B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3A6B7B9E-7395-B107-639D-1B374D775A53}"/>
              </a:ext>
            </a:extLst>
          </p:cNvPr>
          <p:cNvSpPr txBox="1"/>
          <p:nvPr/>
        </p:nvSpPr>
        <p:spPr>
          <a:xfrm>
            <a:off x="323850" y="44395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7A42309A-1DB6-E633-7ED7-C30502684BE8}"/>
              </a:ext>
            </a:extLst>
          </p:cNvPr>
          <p:cNvSpPr txBox="1"/>
          <p:nvPr/>
        </p:nvSpPr>
        <p:spPr>
          <a:xfrm>
            <a:off x="323850" y="463871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2558262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C558ADD1-9D8B-1321-1273-653891B776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000" y="2703216"/>
            <a:ext cx="5400000" cy="2942966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C6D814BA-FEA2-97E6-DCF2-5A0368399C84}"/>
              </a:ext>
            </a:extLst>
          </p:cNvPr>
          <p:cNvSpPr txBox="1"/>
          <p:nvPr/>
        </p:nvSpPr>
        <p:spPr>
          <a:xfrm>
            <a:off x="2114121" y="8774668"/>
            <a:ext cx="2629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</a:t>
            </a:r>
            <a:r>
              <a:rPr lang="fr-FR" b="1" dirty="0"/>
              <a:t>Figure 9 C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46D28316-B198-416C-543C-275071E2D354}"/>
              </a:ext>
            </a:extLst>
          </p:cNvPr>
          <p:cNvSpPr txBox="1"/>
          <p:nvPr/>
        </p:nvSpPr>
        <p:spPr>
          <a:xfrm>
            <a:off x="323850" y="76735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9267178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 9">
            <a:extLst>
              <a:ext uri="{FF2B5EF4-FFF2-40B4-BE49-F238E27FC236}">
                <a16:creationId xmlns:a16="http://schemas.microsoft.com/office/drawing/2014/main" id="{06411CFD-2030-C72E-1E33-688F5642E8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9576" y="2724074"/>
            <a:ext cx="5358848" cy="2213040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650DB28E-E621-7003-1845-93D7186E6214}"/>
              </a:ext>
            </a:extLst>
          </p:cNvPr>
          <p:cNvSpPr txBox="1"/>
          <p:nvPr/>
        </p:nvSpPr>
        <p:spPr>
          <a:xfrm>
            <a:off x="2201485" y="8774668"/>
            <a:ext cx="2572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</a:t>
            </a:r>
            <a:r>
              <a:rPr lang="fr-FR" b="1" dirty="0"/>
              <a:t>Figure 10</a:t>
            </a:r>
          </a:p>
        </p:txBody>
      </p:sp>
      <p:grpSp>
        <p:nvGrpSpPr>
          <p:cNvPr id="27" name="Groupe 26">
            <a:extLst>
              <a:ext uri="{FF2B5EF4-FFF2-40B4-BE49-F238E27FC236}">
                <a16:creationId xmlns:a16="http://schemas.microsoft.com/office/drawing/2014/main" id="{AAF3A002-50E2-AB4F-53FB-FC16F494B9D2}"/>
              </a:ext>
            </a:extLst>
          </p:cNvPr>
          <p:cNvGrpSpPr/>
          <p:nvPr/>
        </p:nvGrpSpPr>
        <p:grpSpPr>
          <a:xfrm>
            <a:off x="3595816" y="2199503"/>
            <a:ext cx="1408670" cy="370702"/>
            <a:chOff x="3595816" y="2199503"/>
            <a:chExt cx="1408670" cy="370702"/>
          </a:xfrm>
        </p:grpSpPr>
        <p:cxnSp>
          <p:nvCxnSpPr>
            <p:cNvPr id="25" name="Connecteur droit 24">
              <a:extLst>
                <a:ext uri="{FF2B5EF4-FFF2-40B4-BE49-F238E27FC236}">
                  <a16:creationId xmlns:a16="http://schemas.microsoft.com/office/drawing/2014/main" id="{6ED3D2AC-C1D5-9E62-D976-09EBB211203A}"/>
                </a:ext>
              </a:extLst>
            </p:cNvPr>
            <p:cNvCxnSpPr>
              <a:cxnSpLocks/>
            </p:cNvCxnSpPr>
            <p:nvPr/>
          </p:nvCxnSpPr>
          <p:spPr>
            <a:xfrm>
              <a:off x="3595816" y="2570205"/>
              <a:ext cx="140867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F7A3E435-C4B4-32CA-DEDE-5B755B6D4E8A}"/>
                </a:ext>
              </a:extLst>
            </p:cNvPr>
            <p:cNvSpPr txBox="1"/>
            <p:nvPr/>
          </p:nvSpPr>
          <p:spPr>
            <a:xfrm>
              <a:off x="3953261" y="2199503"/>
              <a:ext cx="6937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RT (-)</a:t>
              </a:r>
              <a:endParaRPr lang="it-IT" b="1" dirty="0"/>
            </a:p>
          </p:txBody>
        </p:sp>
      </p:grpSp>
      <p:grpSp>
        <p:nvGrpSpPr>
          <p:cNvPr id="28" name="Groupe 27">
            <a:extLst>
              <a:ext uri="{FF2B5EF4-FFF2-40B4-BE49-F238E27FC236}">
                <a16:creationId xmlns:a16="http://schemas.microsoft.com/office/drawing/2014/main" id="{3C322173-9B00-ED44-C17F-AE84920500AA}"/>
              </a:ext>
            </a:extLst>
          </p:cNvPr>
          <p:cNvGrpSpPr/>
          <p:nvPr/>
        </p:nvGrpSpPr>
        <p:grpSpPr>
          <a:xfrm>
            <a:off x="1829701" y="2187562"/>
            <a:ext cx="1408670" cy="370702"/>
            <a:chOff x="3595816" y="2199503"/>
            <a:chExt cx="1408670" cy="370702"/>
          </a:xfrm>
        </p:grpSpPr>
        <p:cxnSp>
          <p:nvCxnSpPr>
            <p:cNvPr id="29" name="Connecteur droit 28">
              <a:extLst>
                <a:ext uri="{FF2B5EF4-FFF2-40B4-BE49-F238E27FC236}">
                  <a16:creationId xmlns:a16="http://schemas.microsoft.com/office/drawing/2014/main" id="{A33A2A58-EA46-5EFB-565B-5011C5BAB2CB}"/>
                </a:ext>
              </a:extLst>
            </p:cNvPr>
            <p:cNvCxnSpPr>
              <a:cxnSpLocks/>
            </p:cNvCxnSpPr>
            <p:nvPr/>
          </p:nvCxnSpPr>
          <p:spPr>
            <a:xfrm>
              <a:off x="3595816" y="2570205"/>
              <a:ext cx="140867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9ABF4870-A891-94CC-3457-CF0996D9730F}"/>
                </a:ext>
              </a:extLst>
            </p:cNvPr>
            <p:cNvSpPr txBox="1"/>
            <p:nvPr/>
          </p:nvSpPr>
          <p:spPr>
            <a:xfrm>
              <a:off x="3953261" y="2199503"/>
              <a:ext cx="7386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RT (+)</a:t>
              </a:r>
              <a:endParaRPr lang="it-IT" b="1" dirty="0"/>
            </a:p>
          </p:txBody>
        </p:sp>
      </p:grpSp>
      <p:sp>
        <p:nvSpPr>
          <p:cNvPr id="22" name="ZoneTexte 21">
            <a:extLst>
              <a:ext uri="{FF2B5EF4-FFF2-40B4-BE49-F238E27FC236}">
                <a16:creationId xmlns:a16="http://schemas.microsoft.com/office/drawing/2014/main" id="{0115C84C-6368-A570-B20C-02149BF32ABD}"/>
              </a:ext>
            </a:extLst>
          </p:cNvPr>
          <p:cNvSpPr txBox="1"/>
          <p:nvPr/>
        </p:nvSpPr>
        <p:spPr>
          <a:xfrm>
            <a:off x="1999655" y="449785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chemeClr val="bg1"/>
                </a:solidFill>
              </a:rPr>
              <a:t>1</a:t>
            </a:r>
            <a:endParaRPr lang="it-IT" b="1" dirty="0">
              <a:solidFill>
                <a:schemeClr val="bg1"/>
              </a:solidFill>
            </a:endParaRP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91311834-B818-7627-90A5-378506ACBB6A}"/>
              </a:ext>
            </a:extLst>
          </p:cNvPr>
          <p:cNvSpPr txBox="1"/>
          <p:nvPr/>
        </p:nvSpPr>
        <p:spPr>
          <a:xfrm>
            <a:off x="2802371" y="449785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chemeClr val="bg1"/>
                </a:solidFill>
              </a:rPr>
              <a:t>2</a:t>
            </a:r>
            <a:endParaRPr lang="it-IT" b="1" dirty="0">
              <a:solidFill>
                <a:schemeClr val="bg1"/>
              </a:solidFill>
            </a:endParaRP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A82A92A5-05EA-0004-9AAF-1C28A287E380}"/>
              </a:ext>
            </a:extLst>
          </p:cNvPr>
          <p:cNvSpPr txBox="1"/>
          <p:nvPr/>
        </p:nvSpPr>
        <p:spPr>
          <a:xfrm>
            <a:off x="3825528" y="449785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chemeClr val="bg1"/>
                </a:solidFill>
              </a:rPr>
              <a:t>1</a:t>
            </a:r>
            <a:endParaRPr lang="it-IT" b="1" dirty="0">
              <a:solidFill>
                <a:schemeClr val="bg1"/>
              </a:solidFill>
            </a:endParaRP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DD9BD12B-A832-EBD0-BC94-CFCDBCF6398F}"/>
              </a:ext>
            </a:extLst>
          </p:cNvPr>
          <p:cNvSpPr txBox="1"/>
          <p:nvPr/>
        </p:nvSpPr>
        <p:spPr>
          <a:xfrm>
            <a:off x="4615885" y="449785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chemeClr val="bg1"/>
                </a:solidFill>
              </a:rPr>
              <a:t>2</a:t>
            </a:r>
            <a:endParaRPr lang="it-IT" b="1" dirty="0">
              <a:solidFill>
                <a:schemeClr val="bg1"/>
              </a:solidFill>
            </a:endParaRP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C464B4EC-CAB1-6B7F-5951-F608E75EF502}"/>
              </a:ext>
            </a:extLst>
          </p:cNvPr>
          <p:cNvGrpSpPr/>
          <p:nvPr/>
        </p:nvGrpSpPr>
        <p:grpSpPr>
          <a:xfrm flipH="1">
            <a:off x="6079870" y="3108688"/>
            <a:ext cx="673582" cy="1765644"/>
            <a:chOff x="1539308" y="5189220"/>
            <a:chExt cx="688696" cy="2373392"/>
          </a:xfrm>
        </p:grpSpPr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CAC9FA72-F0D3-AB6C-CE3F-A038A2C4F306}"/>
                </a:ext>
              </a:extLst>
            </p:cNvPr>
            <p:cNvSpPr txBox="1"/>
            <p:nvPr/>
          </p:nvSpPr>
          <p:spPr>
            <a:xfrm>
              <a:off x="1630678" y="7193280"/>
              <a:ext cx="5952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dirty="0"/>
                <a:t>- </a:t>
              </a:r>
              <a:r>
                <a:rPr lang="fr-FR" sz="1400" dirty="0"/>
                <a:t>100</a:t>
              </a:r>
              <a:endParaRPr lang="it-IT" dirty="0"/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F78FB424-B984-3D3D-B546-1038612F9EC0}"/>
                </a:ext>
              </a:extLst>
            </p:cNvPr>
            <p:cNvSpPr txBox="1"/>
            <p:nvPr/>
          </p:nvSpPr>
          <p:spPr>
            <a:xfrm>
              <a:off x="1630678" y="6606540"/>
              <a:ext cx="5952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dirty="0"/>
                <a:t>- </a:t>
              </a:r>
              <a:r>
                <a:rPr lang="fr-FR" sz="1400" dirty="0"/>
                <a:t>200</a:t>
              </a:r>
              <a:endParaRPr lang="it-IT" dirty="0"/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819A4F44-E89E-B887-F671-9B268F986113}"/>
                </a:ext>
              </a:extLst>
            </p:cNvPr>
            <p:cNvSpPr txBox="1"/>
            <p:nvPr/>
          </p:nvSpPr>
          <p:spPr>
            <a:xfrm>
              <a:off x="1630678" y="6248400"/>
              <a:ext cx="5952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dirty="0"/>
                <a:t>- </a:t>
              </a:r>
              <a:r>
                <a:rPr lang="fr-FR" sz="1400" dirty="0"/>
                <a:t>300</a:t>
              </a:r>
              <a:endParaRPr lang="it-IT" dirty="0"/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57DF0D60-5B49-B037-32BB-64E91F4C4574}"/>
                </a:ext>
              </a:extLst>
            </p:cNvPr>
            <p:cNvSpPr txBox="1"/>
            <p:nvPr/>
          </p:nvSpPr>
          <p:spPr>
            <a:xfrm>
              <a:off x="1630677" y="6027420"/>
              <a:ext cx="5952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dirty="0"/>
                <a:t>- </a:t>
              </a:r>
              <a:r>
                <a:rPr lang="fr-FR" sz="1400" dirty="0"/>
                <a:t>400</a:t>
              </a:r>
              <a:endParaRPr lang="it-IT" dirty="0"/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14CD3C32-4EE2-C050-961F-84484309AAF3}"/>
                </a:ext>
              </a:extLst>
            </p:cNvPr>
            <p:cNvSpPr txBox="1"/>
            <p:nvPr/>
          </p:nvSpPr>
          <p:spPr>
            <a:xfrm>
              <a:off x="1630677" y="5859780"/>
              <a:ext cx="5952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dirty="0"/>
                <a:t>- </a:t>
              </a:r>
              <a:r>
                <a:rPr lang="fr-FR" sz="1400" dirty="0"/>
                <a:t>500</a:t>
              </a:r>
              <a:endParaRPr lang="it-IT" dirty="0"/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6418E37C-FE1A-F362-45BF-AA078387CF77}"/>
                </a:ext>
              </a:extLst>
            </p:cNvPr>
            <p:cNvSpPr txBox="1"/>
            <p:nvPr/>
          </p:nvSpPr>
          <p:spPr>
            <a:xfrm>
              <a:off x="1539308" y="5189220"/>
              <a:ext cx="6886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dirty="0"/>
                <a:t>- </a:t>
              </a:r>
              <a:r>
                <a:rPr lang="fr-FR" sz="1400" dirty="0"/>
                <a:t>1000</a:t>
              </a:r>
              <a:endParaRPr lang="it-IT" dirty="0"/>
            </a:p>
          </p:txBody>
        </p:sp>
      </p:grpSp>
      <p:grpSp>
        <p:nvGrpSpPr>
          <p:cNvPr id="17" name="Groupe 16">
            <a:extLst>
              <a:ext uri="{FF2B5EF4-FFF2-40B4-BE49-F238E27FC236}">
                <a16:creationId xmlns:a16="http://schemas.microsoft.com/office/drawing/2014/main" id="{96664D55-D818-6D24-2FE6-1BFFA0649F61}"/>
              </a:ext>
            </a:extLst>
          </p:cNvPr>
          <p:cNvGrpSpPr/>
          <p:nvPr/>
        </p:nvGrpSpPr>
        <p:grpSpPr>
          <a:xfrm>
            <a:off x="178233" y="3104945"/>
            <a:ext cx="673582" cy="1860218"/>
            <a:chOff x="53045" y="2916880"/>
            <a:chExt cx="673582" cy="1860218"/>
          </a:xfrm>
        </p:grpSpPr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7A3ABB79-4B8F-66F8-C0F6-B9088842BF82}"/>
                </a:ext>
              </a:extLst>
            </p:cNvPr>
            <p:cNvSpPr txBox="1"/>
            <p:nvPr/>
          </p:nvSpPr>
          <p:spPr>
            <a:xfrm flipH="1">
              <a:off x="55052" y="3415732"/>
              <a:ext cx="5822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400" dirty="0"/>
                <a:t>500</a:t>
              </a:r>
              <a:r>
                <a:rPr lang="fr-FR" dirty="0"/>
                <a:t> -</a:t>
              </a:r>
              <a:endParaRPr lang="it-IT" dirty="0"/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F2D113E7-E25F-C424-C47F-A055023F6099}"/>
                </a:ext>
              </a:extLst>
            </p:cNvPr>
            <p:cNvSpPr txBox="1"/>
            <p:nvPr/>
          </p:nvSpPr>
          <p:spPr>
            <a:xfrm flipH="1">
              <a:off x="55051" y="4407766"/>
              <a:ext cx="5822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400" dirty="0"/>
                <a:t>100</a:t>
              </a:r>
              <a:r>
                <a:rPr lang="fr-FR" dirty="0"/>
                <a:t> -</a:t>
              </a:r>
              <a:endParaRPr lang="it-IT" dirty="0"/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4815810F-8BCD-4A81-901A-88A8A39B50CD}"/>
                </a:ext>
              </a:extLst>
            </p:cNvPr>
            <p:cNvSpPr txBox="1"/>
            <p:nvPr/>
          </p:nvSpPr>
          <p:spPr>
            <a:xfrm flipH="1">
              <a:off x="55051" y="3971271"/>
              <a:ext cx="5822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400" dirty="0"/>
                <a:t>200</a:t>
              </a:r>
              <a:r>
                <a:rPr lang="fr-FR" dirty="0"/>
                <a:t> -</a:t>
              </a:r>
              <a:endParaRPr lang="it-IT" dirty="0"/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711DFC61-D46F-FCAE-D6CA-2980B5CF39C1}"/>
                </a:ext>
              </a:extLst>
            </p:cNvPr>
            <p:cNvSpPr txBox="1"/>
            <p:nvPr/>
          </p:nvSpPr>
          <p:spPr>
            <a:xfrm flipH="1">
              <a:off x="55051" y="3704839"/>
              <a:ext cx="5822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400" dirty="0"/>
                <a:t>300</a:t>
              </a:r>
              <a:r>
                <a:rPr lang="fr-FR" dirty="0"/>
                <a:t> -</a:t>
              </a:r>
              <a:endParaRPr lang="it-IT" dirty="0"/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01CFF087-3B4D-601D-ED04-784D1DC5156D}"/>
                </a:ext>
              </a:extLst>
            </p:cNvPr>
            <p:cNvSpPr txBox="1"/>
            <p:nvPr/>
          </p:nvSpPr>
          <p:spPr>
            <a:xfrm flipH="1">
              <a:off x="55052" y="3540444"/>
              <a:ext cx="5822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400" dirty="0"/>
                <a:t>400</a:t>
              </a:r>
              <a:r>
                <a:rPr lang="fr-FR" dirty="0"/>
                <a:t> -</a:t>
              </a:r>
              <a:endParaRPr lang="it-IT" dirty="0"/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DF2A593A-8F00-6292-E785-2BCEE3B5069F}"/>
                </a:ext>
              </a:extLst>
            </p:cNvPr>
            <p:cNvSpPr txBox="1"/>
            <p:nvPr/>
          </p:nvSpPr>
          <p:spPr>
            <a:xfrm flipH="1">
              <a:off x="53045" y="2916880"/>
              <a:ext cx="6735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400" dirty="0"/>
                <a:t>1000</a:t>
              </a:r>
              <a:r>
                <a:rPr lang="fr-FR" dirty="0"/>
                <a:t> -</a:t>
              </a:r>
              <a:endParaRPr lang="it-IT" dirty="0"/>
            </a:p>
          </p:txBody>
        </p:sp>
      </p:grpSp>
    </p:spTree>
    <p:extLst>
      <p:ext uri="{BB962C8B-B14F-4D97-AF65-F5344CB8AC3E}">
        <p14:creationId xmlns:p14="http://schemas.microsoft.com/office/powerpoint/2010/main" val="2017791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">
            <a:extLst>
              <a:ext uri="{FF2B5EF4-FFF2-40B4-BE49-F238E27FC236}">
                <a16:creationId xmlns:a16="http://schemas.microsoft.com/office/drawing/2014/main" id="{02060648-2F40-1675-33DC-EC6D1B0369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9000" y="702000"/>
            <a:ext cx="5760000" cy="62786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ClrTx/>
              <a:buSzTx/>
              <a:buFontTx/>
              <a:buNone/>
              <a:tabLst/>
            </a:pPr>
            <a:r>
              <a:rPr kumimoji="0" lang="en-US" altLang="fr-FR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s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Map of the tethered candidate poly(A) polymerase plasmids.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λ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APαm7 plasmid given as an example.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Garamond" panose="02020404030301010803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Map of the C3P3-G1 plasmid.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Garamond" panose="02020404030301010803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Map of the Firefly luciferase reporter plasmids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K1E-Luciferase-4xλBoxBr-A40 plasmid is given as an example.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Garamond" panose="02020404030301010803" pitchFamily="18" charset="0"/>
            </a:endParaRPr>
          </a:p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Optimization of the design of </a:t>
            </a:r>
            <a:r>
              <a:rPr kumimoji="0" lang="en-US" altLang="fr-FR" sz="12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xB</a:t>
            </a: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ethering hairpins in the 3’UTR of target mRNA. 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rst series, comparison of between 4xλBoxBr and 4xλBoxBl tethering hairpins from the λ virus. Second series, optimization of the number of tandem BoxBr introduced into the 3’UTR of the target mRNA of Firefly luciferase, ranging from 0 to 12 boxes. Third series, optimization of the spacing between each of BoxBr, ranging from 0 to 40 nucleotides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K-293 cells were co-transfected as described above. Constructions were tested for luciferin oxidation assays 48 hours after transfection and expressed as RLU divided by the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SEAP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tein expression expressed in DO (RLU/DO ratio) and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ized to the reference group (R)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Values represent the mean ± SD (n ≥ 4). Statistical analysis was performed by ANOVA adjusted by Dunnett’s Post Hoc analysis for multiple comparisons with cells transfected with the C3P3-G1 plasmid only, (*, P&lt;0.05; **, P&lt;0.01; ***, P&lt;0.001; **** P&lt;0.0001).</a:t>
            </a:r>
          </a:p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. The 4xλBoxBr/</a:t>
            </a:r>
            <a:r>
              <a:rPr kumimoji="0" lang="en-US" altLang="fr-FR" sz="12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λ</a:t>
            </a: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APαm7 polyadenylation system requires both intact components and can be used for the expression of other reporter proteins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K-293 cells were co-transfected as described above with the C3P3-G1 plasmid and the following controls: (A) the standard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λ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APαm7, the catalytically inactive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λ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APαm7[D115A] mutant or no poly(A) polymerase. (B) the Firefly luciferase reporter plasmid containing four standard BoxBr (4xλBoxBr), scrambled BoxBr (4xλscBoxBr) or no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λBoxBr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0xλBoxBr). Constructions were tested for luciferin oxidation assays 48 hours after transfection and expressed as RLU divided by the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SEAP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tein expression expressed in DO (RLU/DO ratio) and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ized to the reference group (R)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present the mean ± SD (n ≥ 4). Statistical analysis was performed by ANOVA adjusted by Dunnett’s Post Hoc analysis for multiple comparisons (*, P&lt;0.05; **, P&lt;0.01; ***, P&lt;0.001; **** P&lt;0.0001).</a:t>
            </a:r>
          </a:p>
        </p:txBody>
      </p:sp>
    </p:spTree>
    <p:extLst>
      <p:ext uri="{BB962C8B-B14F-4D97-AF65-F5344CB8AC3E}">
        <p14:creationId xmlns:p14="http://schemas.microsoft.com/office/powerpoint/2010/main" val="1939991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650DB28E-E621-7003-1845-93D7186E6214}"/>
              </a:ext>
            </a:extLst>
          </p:cNvPr>
          <p:cNvSpPr txBox="1"/>
          <p:nvPr/>
        </p:nvSpPr>
        <p:spPr>
          <a:xfrm>
            <a:off x="2201485" y="8774668"/>
            <a:ext cx="2572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</a:t>
            </a:r>
            <a:r>
              <a:rPr lang="fr-FR" b="1" dirty="0"/>
              <a:t>Figure 11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164945E5-7B39-C894-4F11-02AC541A59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000" y="2535296"/>
            <a:ext cx="5400000" cy="32074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06211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">
            <a:extLst>
              <a:ext uri="{FF2B5EF4-FFF2-40B4-BE49-F238E27FC236}">
                <a16:creationId xmlns:a16="http://schemas.microsoft.com/office/drawing/2014/main" id="{02060648-2F40-1675-33DC-EC6D1B0369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9000" y="702000"/>
            <a:ext cx="5760000" cy="74174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. The 4xλBoxBr/</a:t>
            </a:r>
            <a:r>
              <a:rPr kumimoji="0" lang="en-US" altLang="fr-FR" sz="12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λ</a:t>
            </a: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APαm7 polyadenylation system can be used for the expression of other reporter proteins and with various constructions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HEK-293 cells were co-transfected as described above with the C3P3-G1 plasmid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GFP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porter gene plasmid, followed by the analysis of the fluorescent cells by flow cytometry. For testing various constructions, HEK-293 cells were transfected and assayed as described previously. Plasmids containing the following sequences were tested: (B) with various 5’UTR introduced in the Firefly luciferase reporter plasmid , including sequences from mouse beta-globin (5’UTR:mHBB; Genbank NM_001278161.1), human beta-globin (5’UTR:hHBB; Genbank NM_000518.4) and human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hymosin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pha mRNA (5’UTR:hPTMA; Genbank NM_002823.5) or no 5’UTR, (C) as well as several 3’UTR, including one or two 3’UTR in tandem from human beta-globin (3’UTR:hHBB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’UTR:hHBB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3’UTR:2xhHBB; Genbank), Xenopus laevis beta-globin (3’UTR:xlHBB; Genbank NM_000518.4) and human 12S rRNA (3’UTR:mtRNR1; V01433.1). Constructions were tested for luciferin oxidation assays 48 hours after transfection and expressed as RLU divided by the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SEAP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tein expression expressed in DO (RLU/DO ratio) and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ized to the reference group (R)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present the mean ± SD (n ≥ 4). Statistical analysis was performed by ANOVA adjusted by Dunnett’s Post Hoc analysis for multiple comparisons (*, P&lt;0.05; **, P&lt;0.01; ***, P&lt;0.001; **** P&lt;0.0001).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Garamond" panose="02020404030301010803" pitchFamily="18" charset="0"/>
            </a:endParaRPr>
          </a:p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lang="en-US" altLang="fr-FR" sz="1200" b="1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7. 4xλBoxBr/</a:t>
            </a:r>
            <a:r>
              <a:rPr lang="en-US" altLang="fr-FR" sz="1200" b="1" dirty="0" err="1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λ</a:t>
            </a:r>
            <a:r>
              <a:rPr lang="en-US" altLang="fr-FR" sz="1200" b="1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APαm7 system also increases the performances of the C3P3-G1 system in rodent cells lines. </a:t>
            </a:r>
            <a:r>
              <a:rPr lang="en-US" altLang="fr-FR" sz="1200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following cell lines were transfected and assayed according to the same methods as previously described, i.e. (A), rat K-9 hepatocytes, (B) Chinese hamster CHO-K1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(C) mouse NIH 3T3 cell lines</a:t>
            </a:r>
            <a:r>
              <a:rPr lang="en-US" altLang="fr-FR" sz="1200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structions were tested for luciferin oxidation assays 48 hours after transfection and expressed as RLU divided by the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SEAP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tein expression expressed in DO (RLU/DO ratio) and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ized to the reference group (R)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altLang="fr-FR" sz="1200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present the mean ± SD (n ≥ 4). Statistical analysis was performed by ANOVA adjusted by Dunnett’s Post Hoc analysis for multiple comparisons (*, P&lt;0.05; **, P&lt;0.01; ***, P&lt;0.001; **** P&lt;0.0001).</a:t>
            </a:r>
            <a:endParaRPr lang="fr-FR" altLang="fr-FR" sz="1200" dirty="0">
              <a:latin typeface="Garamond" panose="02020404030301010803" pitchFamily="18" charset="0"/>
            </a:endParaRPr>
          </a:p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8. Firefly luciferase mRNA synthesis induced cell proliferation and cytotoxicity with the C3P3 system. 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HEK-293 (A-B)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hinese hamster CHO-K1 (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-D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 lines were co-transfected with 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C3P3-G1 (NP868R-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4S)2-K1ERNAP[R551S]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catalytically-dead C3P3-G1 (NP868R-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4S)4-K1ERNAP[R627S]), 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3P3-G2 (N</a:t>
            </a:r>
            <a:r>
              <a:rPr lang="el-GR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λ-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P</a:t>
            </a:r>
            <a:r>
              <a:rPr lang="el-GR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7), catalytically-dead C3P3-G2 (N</a:t>
            </a:r>
            <a:r>
              <a:rPr lang="el-GR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λ-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P</a:t>
            </a:r>
            <a:r>
              <a:rPr lang="el-GR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7[D115A]), and/or the pK1E-Luciferase-4x</a:t>
            </a:r>
            <a:r>
              <a:rPr lang="el-GR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λ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xBr-A40 plasmids. Cells were cultured and transfected as described above. Cell proliferation and death were assayed 48 hours after transfection respectively </a:t>
            </a:r>
            <a:r>
              <a:rPr lang="en-US" altLang="fr-FR" sz="1200" dirty="0" err="1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QUANT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rect Cell Proliferation (A and C) or the </a:t>
            </a:r>
            <a:r>
              <a:rPr lang="en-US" altLang="fr-FR" sz="1200" dirty="0" err="1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QUANT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DH Cytotoxicity assays 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D)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present the mean ± SD (n ≥ 4). Statistical analysis was performed by ANOVA adjusted by Dunnett’s Post Hoc analysis for multiple comparisons (*, P&lt;0.05; **, P&lt;0.01; ***, P&lt;0.001; **** P&lt;0.0001).</a:t>
            </a:r>
            <a:endParaRPr kumimoji="0" lang="en-US" altLang="fr-FR" sz="1200" i="0" u="none" strike="noStrike" cap="none" normalizeH="0" baseline="0" dirty="0">
              <a:ln>
                <a:noFill/>
              </a:ln>
              <a:solidFill>
                <a:srgbClr val="FF0000"/>
              </a:solidFill>
              <a:effectLst/>
              <a:latin typeface="Garamond" panose="02020404030301010803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99397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084F6BCF-C243-3E12-9ACE-956EBF21B9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9000" y="702000"/>
            <a:ext cx="5760000" cy="57554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9. Comparison to various alternatives to polyadenylation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rious constructions were compared to artificial polyadenylation by the 4xλBoxBr/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λ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APαm7 system, Plasmids containing the following sequences were tested: (A) human H3 clustered histone 10 (H3C10) stem-loop, which was introduced in the 3’UTR of the Firefly luciferase reporter plasmid with or without a 40-adenosine residues track, (B) various sequences that can substitute to standard polyadenylation including the 3’UTR of the S-segment from Bunyamwera orthobunyavirus, Andes hantavirus and dengue virus type 2, and (C) a 10-residue polycytosine track placed immediately downstream of the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lyadenosine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rack (A40C10). Constructions were tested for luciferin oxidation assays 48 hours after transfection and expressed as RLU divided by the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SEAP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tein expression expressed in DO (RLU/DO ratio) and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ized to the reference group (R)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present the mean ± SD (n ≥ 4). Statistical analysis was performed by ANOVA adjusted by Dunnett’s Post Hoc analysis for multiple comparisons (*, P&lt;0.05; **, P&lt;0.01; ***, P&lt;0.001; **** P&lt;0.0001).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0. mRNA tailing assay with gene-specific forward primer#2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poly(A)-tailing assay was performed as described in the Material and Method section, except the gene-specific forward primer used (Supplementary Table 7). The resulting PCR products run on 2.5% agarose gel are the following: track 1: Firefly Luciferase mRNA produced with C3P3 only; track 2: Firefly Luciferase mRNA produced with C3P3 and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λ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APαm7. Left, with reverse-transcription; right, without reverse-transcription.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Garamond" panose="02020404030301010803" pitchFamily="18" charset="0"/>
            </a:endParaRPr>
          </a:p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1</a:t>
            </a:r>
            <a:r>
              <a:rPr lang="en-US" altLang="fr-FR" sz="1200" b="1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ffects of </a:t>
            </a:r>
            <a:r>
              <a:rPr kumimoji="0" lang="en-US" altLang="fr-FR" sz="1200" b="1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λ</a:t>
            </a: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tethering of the main proteins involved in the closed-loop mRNA formation on Firefly luciferase reporter protein expression. 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ORF of the following proteins were fused at their N-terminus 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 a N</a:t>
            </a:r>
            <a:r>
              <a:rPr lang="el-GR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λ</a:t>
            </a:r>
            <a:r>
              <a:rPr lang="fr-FR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fr-FR" altLang="fr-FR" sz="1200" dirty="0" err="1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ethering</a:t>
            </a:r>
            <a:r>
              <a:rPr lang="fr-FR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altLang="fr-FR" sz="1200" dirty="0" err="1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s</a:t>
            </a:r>
            <a:r>
              <a:rPr lang="fr-FR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BP which binds the poly(A) tail to 3' ends of mRNA, eIF4E which binds to the cap of their 5' ends and eIF4G which bridges these </a:t>
            </a:r>
            <a:r>
              <a:rPr lang="en-US" altLang="fr-FR" sz="1200" dirty="0">
                <a:solidFill>
                  <a:srgbClr val="FF0000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wo proteins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structions were tested for luciferin oxidation assays 48 hours after transfection and expressed as RLU divided by the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SEAP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tein expression expressed in DO (RLU/DO ratio) and normalized to the reference group (R)</a:t>
            </a:r>
            <a:r>
              <a:rPr kumimoji="0" lang="en-US" altLang="fr-FR" sz="12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represent the mean ± SD (n ≥ 4). Statistical analysis was performed by ANOVA adjusted by Dunnett’s Post Hoc analysis for multiple comparisons (*, P&lt;0.05; **, P&lt;0.01; ***, P&lt;0.001; **** P&lt;0.0001). 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rgbClr val="FF0000"/>
              </a:solidFill>
              <a:effectLst/>
              <a:latin typeface="Garamond" panose="02020404030301010803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55867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084F6BCF-C243-3E12-9ACE-956EBF21B9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9000" y="702000"/>
            <a:ext cx="5760000" cy="23083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Video. Time lapse imaging of mRNA produced by the C3P3 system in live cells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ime lapse imaging of mRNA produced by the C3P3 system in live cells was imaged with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martFlare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bes, which are designed to emit fluorescence when they bind a specific target mRNA in live cells (1). CHO-K1 cells were transfected with human leptin reporter plasmid under control of the K1E promoter together with the C3P3-G1 plasmid, then incubated in presence of the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martFlare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be targeting the human leptin mRNA. Live cells were incubated at 37°C in standard culture medium, then continuously imaged for two days. Acquisition of fluorescent signal and transmitted light was achieved every 5 minutes by confocal fluorescence microscopy with ×40 objective. The result is a movie that shows that red fluorescent signal appeared approximately eight hours after transfection and progressively increased during the recording period. mRNA was imaged as speck-like fluorescent clusters in cytoplasm of transfected cells, with no detectable nuclear signal.</a:t>
            </a:r>
            <a:endParaRPr kumimoji="0" lang="en-US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Garamond" panose="02020404030301010803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8896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ZoneTexte 10">
            <a:extLst>
              <a:ext uri="{FF2B5EF4-FFF2-40B4-BE49-F238E27FC236}">
                <a16:creationId xmlns:a16="http://schemas.microsoft.com/office/drawing/2014/main" id="{D877B285-4B62-D5A0-E4F1-FF591E5D480A}"/>
              </a:ext>
            </a:extLst>
          </p:cNvPr>
          <p:cNvSpPr txBox="1"/>
          <p:nvPr/>
        </p:nvSpPr>
        <p:spPr>
          <a:xfrm>
            <a:off x="2201485" y="8774668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1</a:t>
            </a: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13522C58-7284-E23B-9CF2-EE430168CEC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919432"/>
            <a:ext cx="5400000" cy="5752075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B4F3ED80-F268-B260-0BC0-1F91C02E0C86}"/>
              </a:ext>
            </a:extLst>
          </p:cNvPr>
          <p:cNvSpPr/>
          <p:nvPr/>
        </p:nvSpPr>
        <p:spPr>
          <a:xfrm>
            <a:off x="4656516" y="830744"/>
            <a:ext cx="2201484" cy="4558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4498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3A2D93E5-3476-C6F2-627D-BB06525E9BBC}"/>
              </a:ext>
            </a:extLst>
          </p:cNvPr>
          <p:cNvSpPr txBox="1"/>
          <p:nvPr/>
        </p:nvSpPr>
        <p:spPr>
          <a:xfrm>
            <a:off x="2201485" y="8774668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2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4246C156-4165-E050-9130-D2DF8A0C2F1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919432"/>
            <a:ext cx="5400000" cy="575207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61364653-7D94-FDAD-C716-0FFE86FA3EE9}"/>
              </a:ext>
            </a:extLst>
          </p:cNvPr>
          <p:cNvSpPr/>
          <p:nvPr/>
        </p:nvSpPr>
        <p:spPr>
          <a:xfrm>
            <a:off x="4433977" y="830744"/>
            <a:ext cx="2424023" cy="4558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8972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3A2D93E5-3476-C6F2-627D-BB06525E9BBC}"/>
              </a:ext>
            </a:extLst>
          </p:cNvPr>
          <p:cNvSpPr txBox="1"/>
          <p:nvPr/>
        </p:nvSpPr>
        <p:spPr>
          <a:xfrm>
            <a:off x="2201485" y="8774668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3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11B02063-94AA-FBFF-87C7-A49727F0DD3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5"/>
          <a:stretch/>
        </p:blipFill>
        <p:spPr>
          <a:xfrm>
            <a:off x="598370" y="1321146"/>
            <a:ext cx="5400000" cy="538124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88C813A5-A863-DB8F-580B-CA5CDAC843E8}"/>
              </a:ext>
            </a:extLst>
          </p:cNvPr>
          <p:cNvSpPr/>
          <p:nvPr/>
        </p:nvSpPr>
        <p:spPr>
          <a:xfrm>
            <a:off x="4830792" y="1286640"/>
            <a:ext cx="2027208" cy="4558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6192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52959A35-C8A5-D53E-27B8-A13C9299EDCD}"/>
              </a:ext>
            </a:extLst>
          </p:cNvPr>
          <p:cNvSpPr txBox="1"/>
          <p:nvPr/>
        </p:nvSpPr>
        <p:spPr>
          <a:xfrm>
            <a:off x="1714500" y="8774668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b="1" dirty="0"/>
              <a:t>Supplementary Figure 4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DA0BCB41-57D9-4E45-E0FD-F46E19F0C4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76855"/>
            <a:ext cx="6858000" cy="55902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834280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05</TotalTime>
  <Words>2334</Words>
  <Application>Microsoft Office PowerPoint</Application>
  <PresentationFormat>Affichage à l'écran (4:3)</PresentationFormat>
  <Paragraphs>401</Paragraphs>
  <Slides>20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0</vt:i4>
      </vt:variant>
    </vt:vector>
  </HeadingPairs>
  <TitlesOfParts>
    <vt:vector size="24" baseType="lpstr">
      <vt:lpstr>Arial</vt:lpstr>
      <vt:lpstr>Calibri</vt:lpstr>
      <vt:lpstr>Garamond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hilippe JAIS</dc:creator>
  <cp:lastModifiedBy>Philippe Jais</cp:lastModifiedBy>
  <cp:revision>730</cp:revision>
  <dcterms:created xsi:type="dcterms:W3CDTF">2014-11-16T17:27:22Z</dcterms:created>
  <dcterms:modified xsi:type="dcterms:W3CDTF">2024-02-10T09:33:21Z</dcterms:modified>
</cp:coreProperties>
</file>